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8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a Paola Zuluaga Cruz" userId="5242125e-699b-4307-9ec5-c80953f9d57d" providerId="ADAL" clId="{32A9E505-9DA3-43D0-A1DE-8EDF15CA87E4}"/>
    <pc:docChg chg="delSld">
      <pc:chgData name="Andrea Paola Zuluaga Cruz" userId="5242125e-699b-4307-9ec5-c80953f9d57d" providerId="ADAL" clId="{32A9E505-9DA3-43D0-A1DE-8EDF15CA87E4}" dt="2023-04-10T15:14:40.086" v="10" actId="47"/>
      <pc:docMkLst>
        <pc:docMk/>
      </pc:docMkLst>
      <pc:sldChg chg="del">
        <pc:chgData name="Andrea Paola Zuluaga Cruz" userId="5242125e-699b-4307-9ec5-c80953f9d57d" providerId="ADAL" clId="{32A9E505-9DA3-43D0-A1DE-8EDF15CA87E4}" dt="2023-04-10T15:14:37.201" v="7" actId="47"/>
        <pc:sldMkLst>
          <pc:docMk/>
          <pc:sldMk cId="3268476139" sldId="256"/>
        </pc:sldMkLst>
      </pc:sldChg>
      <pc:sldChg chg="del">
        <pc:chgData name="Andrea Paola Zuluaga Cruz" userId="5242125e-699b-4307-9ec5-c80953f9d57d" providerId="ADAL" clId="{32A9E505-9DA3-43D0-A1DE-8EDF15CA87E4}" dt="2023-04-10T15:14:34.355" v="4" actId="47"/>
        <pc:sldMkLst>
          <pc:docMk/>
          <pc:sldMk cId="4136530590" sldId="257"/>
        </pc:sldMkLst>
      </pc:sldChg>
      <pc:sldChg chg="del">
        <pc:chgData name="Andrea Paola Zuluaga Cruz" userId="5242125e-699b-4307-9ec5-c80953f9d57d" providerId="ADAL" clId="{32A9E505-9DA3-43D0-A1DE-8EDF15CA87E4}" dt="2023-04-10T15:14:39.238" v="9" actId="47"/>
        <pc:sldMkLst>
          <pc:docMk/>
          <pc:sldMk cId="732283716" sldId="258"/>
        </pc:sldMkLst>
      </pc:sldChg>
      <pc:sldChg chg="del">
        <pc:chgData name="Andrea Paola Zuluaga Cruz" userId="5242125e-699b-4307-9ec5-c80953f9d57d" providerId="ADAL" clId="{32A9E505-9DA3-43D0-A1DE-8EDF15CA87E4}" dt="2023-04-10T15:14:31.030" v="0" actId="47"/>
        <pc:sldMkLst>
          <pc:docMk/>
          <pc:sldMk cId="189417496" sldId="572"/>
        </pc:sldMkLst>
      </pc:sldChg>
      <pc:sldChg chg="del">
        <pc:chgData name="Andrea Paola Zuluaga Cruz" userId="5242125e-699b-4307-9ec5-c80953f9d57d" providerId="ADAL" clId="{32A9E505-9DA3-43D0-A1DE-8EDF15CA87E4}" dt="2023-04-10T15:14:31.784" v="1" actId="47"/>
        <pc:sldMkLst>
          <pc:docMk/>
          <pc:sldMk cId="3465028077" sldId="583"/>
        </pc:sldMkLst>
      </pc:sldChg>
      <pc:sldChg chg="del">
        <pc:chgData name="Andrea Paola Zuluaga Cruz" userId="5242125e-699b-4307-9ec5-c80953f9d57d" providerId="ADAL" clId="{32A9E505-9DA3-43D0-A1DE-8EDF15CA87E4}" dt="2023-04-10T15:14:36.260" v="6" actId="47"/>
        <pc:sldMkLst>
          <pc:docMk/>
          <pc:sldMk cId="2910639113" sldId="587"/>
        </pc:sldMkLst>
      </pc:sldChg>
      <pc:sldChg chg="del">
        <pc:chgData name="Andrea Paola Zuluaga Cruz" userId="5242125e-699b-4307-9ec5-c80953f9d57d" providerId="ADAL" clId="{32A9E505-9DA3-43D0-A1DE-8EDF15CA87E4}" dt="2023-04-10T15:14:38.368" v="8" actId="47"/>
        <pc:sldMkLst>
          <pc:docMk/>
          <pc:sldMk cId="3810338556" sldId="588"/>
        </pc:sldMkLst>
      </pc:sldChg>
      <pc:sldChg chg="del">
        <pc:chgData name="Andrea Paola Zuluaga Cruz" userId="5242125e-699b-4307-9ec5-c80953f9d57d" providerId="ADAL" clId="{32A9E505-9DA3-43D0-A1DE-8EDF15CA87E4}" dt="2023-04-10T15:14:32.621" v="2" actId="47"/>
        <pc:sldMkLst>
          <pc:docMk/>
          <pc:sldMk cId="1231451639" sldId="589"/>
        </pc:sldMkLst>
      </pc:sldChg>
      <pc:sldChg chg="del">
        <pc:chgData name="Andrea Paola Zuluaga Cruz" userId="5242125e-699b-4307-9ec5-c80953f9d57d" providerId="ADAL" clId="{32A9E505-9DA3-43D0-A1DE-8EDF15CA87E4}" dt="2023-04-10T15:14:33.455" v="3" actId="47"/>
        <pc:sldMkLst>
          <pc:docMk/>
          <pc:sldMk cId="2493161850" sldId="590"/>
        </pc:sldMkLst>
      </pc:sldChg>
      <pc:sldChg chg="del">
        <pc:chgData name="Andrea Paola Zuluaga Cruz" userId="5242125e-699b-4307-9ec5-c80953f9d57d" providerId="ADAL" clId="{32A9E505-9DA3-43D0-A1DE-8EDF15CA87E4}" dt="2023-04-10T15:14:35.211" v="5" actId="47"/>
        <pc:sldMkLst>
          <pc:docMk/>
          <pc:sldMk cId="3917575293" sldId="591"/>
        </pc:sldMkLst>
      </pc:sldChg>
      <pc:sldChg chg="del">
        <pc:chgData name="Andrea Paola Zuluaga Cruz" userId="5242125e-699b-4307-9ec5-c80953f9d57d" providerId="ADAL" clId="{32A9E505-9DA3-43D0-A1DE-8EDF15CA87E4}" dt="2023-04-10T15:14:40.086" v="10" actId="47"/>
        <pc:sldMkLst>
          <pc:docMk/>
          <pc:sldMk cId="380282021" sldId="59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4C8543-FE57-4232-9774-849BEF1FD4A7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03D5A-D563-4AA8-BD45-12959E87EC96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20211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32D123-7490-496D-BED0-88B338580B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96528CC-B0E2-4B5C-BFC0-A530B94784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304166-CA30-4EB7-86CF-1E5C3589C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696EAB-6093-4D09-B493-34A4EE46B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B5086C-AF2A-4C02-A484-A3CC2FD0E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06155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3B1490-A074-4E35-B70B-ED0E8F5B32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5CE5366-DA6E-48EE-B18C-04885719C4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D17B8C3-7EB0-4972-A677-0D3BDAF11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5D47A9B-10B6-4FCC-8F27-4342AE3D2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C9E08A-2561-4A78-9322-760300EE0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48352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A815AAB-AEC4-404A-87AC-715026266B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E6BAECC-C366-47F5-9BFE-C50FE8269F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27191C5-1612-44E6-8416-5377BBE6D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CF9C278-D498-496B-86D5-9AED1B8B3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FE55F09-5494-476F-BFE4-0CBAB521B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10380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97DF6F-4B7E-4331-AA28-3831F8815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A7306B7-25AF-4EAC-8457-FDB2795468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C69C372-4355-4AF6-A2F1-5070C7E11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6939618-BE1E-4CC4-B62C-1F75EC89B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B048DF2-C19C-4DFE-8371-DE363D4C3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12923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1A5CFD-E577-4534-BE05-F74486857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24CBCCB-3C38-4BAD-A04A-387332C2DE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D310CBA-2338-46FF-BF2C-0FADB009C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0A5B3B6-9E47-4983-8D94-560D8D612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CF622A2-1D38-4E99-9DDF-FA4B23D7E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42806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03A88C-0A46-450D-8667-084BD105D7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B12A5E1-14A6-4E8B-A514-9F621AB597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81AA69E-966D-4CF9-BF8E-FBBFC14A22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CC5FE20-F494-4310-8D09-843BC47BF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7054219-6A08-4B93-8BFF-6728A437C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02A209B-6AA2-4B6A-A446-5D7100557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26947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B41A6A-5B69-42D3-8004-A5E66B0CF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B935561-E776-4B05-B6DD-9937A26581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BA3B3CE-07B9-447D-B8B1-98BDA9E377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D08C287-FD9C-4D27-AA2E-B19442C32E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E867DFB-D770-4432-9867-96C0D10D95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2EDFF1B-F78E-4A3B-BDFF-771AACA02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D847DFF-801D-48F7-A6F4-16C8622F0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5A61F55-A0E3-4CC9-9AD6-4E21AEEBF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64694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5B9B60-3475-4077-A19C-E0D9664456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109D0E4-9982-40FD-86BF-82D0D42A9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75E8DE55-A360-480B-81B9-92CB8BDFF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AE21E0B-3857-466E-9923-954F48988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28989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3894032-04CF-4099-8C0B-AFCC570D7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9FD333A-07F2-40C8-8E8D-6817B8699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B6BE316-0AB4-4D3A-9B9C-25D66B1D4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85667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8F7F4D-0E74-4543-9066-D95BF706C8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E496225-0C69-4995-A2E5-DC920CAF38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2881DB-65D2-4A3D-A425-982A77ECCA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571C4D9-0B2E-41F1-90B0-A4B867B99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3943C76-DD00-4D3C-9589-0212DD273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1B2BFE0-DED0-430A-8723-6FC6D0BDA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41831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F61E98-C8C1-402E-AFC6-1DB93C64B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851EE90-6B34-46EC-B10D-0259758082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0F706C7-0E11-4263-A38B-8FE707582E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6AB6D6B-7D84-4A16-8F62-029CC5AAD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E4AF10B-A394-4688-8F8C-48C1631EE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36371CC-E4DC-46E3-A6A5-B49D1BF8A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09896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8C834B0-D704-477E-84CB-6C283B732F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BC8E4B6-960D-4F06-BA5F-D6A46D4A6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7E620DE-D116-456D-AEEA-72464FE444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43AEA-1905-4B8A-956E-EFC13394670C}" type="datetimeFigureOut">
              <a:rPr lang="es-CO" smtClean="0"/>
              <a:t>10/04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3C2E8B8-B6F4-4D57-9422-0E88BDF158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D28D8B-3197-4D39-BA12-62139CECF6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3DAB5-BFEA-410A-AE79-0A754411053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662973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F77C4D2E-8FBF-F220-519B-1AFFF34ED65A}"/>
              </a:ext>
            </a:extLst>
          </p:cNvPr>
          <p:cNvGrpSpPr/>
          <p:nvPr/>
        </p:nvGrpSpPr>
        <p:grpSpPr>
          <a:xfrm>
            <a:off x="87947" y="493159"/>
            <a:ext cx="11138550" cy="3846620"/>
            <a:chOff x="77673" y="246888"/>
            <a:chExt cx="11138550" cy="3846620"/>
          </a:xfrm>
        </p:grpSpPr>
        <p:pic>
          <p:nvPicPr>
            <p:cNvPr id="5" name="Picture 1" descr="A picture containing bar chart&#10;&#10;Description automatically generated">
              <a:extLst>
                <a:ext uri="{FF2B5EF4-FFF2-40B4-BE49-F238E27FC236}">
                  <a16:creationId xmlns:a16="http://schemas.microsoft.com/office/drawing/2014/main" id="{D6FDB29F-0E21-6747-8324-A1E8F4BDC97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02" r="11679"/>
            <a:stretch/>
          </p:blipFill>
          <p:spPr bwMode="auto">
            <a:xfrm>
              <a:off x="237018" y="673100"/>
              <a:ext cx="5249382" cy="34147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A picture containing bar chart&#10;&#10;Description automatically generated">
              <a:extLst>
                <a:ext uri="{FF2B5EF4-FFF2-40B4-BE49-F238E27FC236}">
                  <a16:creationId xmlns:a16="http://schemas.microsoft.com/office/drawing/2014/main" id="{622517A4-6889-97E8-C2BA-659C91174B4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02" r="11679"/>
            <a:stretch/>
          </p:blipFill>
          <p:spPr bwMode="auto">
            <a:xfrm>
              <a:off x="5966841" y="678795"/>
              <a:ext cx="5249382" cy="34147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 Box 12">
              <a:extLst>
                <a:ext uri="{FF2B5EF4-FFF2-40B4-BE49-F238E27FC236}">
                  <a16:creationId xmlns:a16="http://schemas.microsoft.com/office/drawing/2014/main" id="{60808CAE-999E-6EA3-117B-B337E54AAA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8585" y="264500"/>
              <a:ext cx="1498600" cy="2413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CO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onducive</a:t>
              </a:r>
              <a:endParaRPr kumimoji="0" lang="es-CO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 Box 13">
              <a:extLst>
                <a:ext uri="{FF2B5EF4-FFF2-40B4-BE49-F238E27FC236}">
                  <a16:creationId xmlns:a16="http://schemas.microsoft.com/office/drawing/2014/main" id="{3229F17C-22B0-617B-C072-79178BB7E8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75662" y="263830"/>
              <a:ext cx="1498600" cy="2413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opagated</a:t>
              </a:r>
              <a:r>
                <a:rPr kumimoji="0" lang="es-MX" altLang="es-CO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onventional</a:t>
              </a:r>
              <a:endParaRPr kumimoji="0" lang="es-MX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 Box 14">
              <a:extLst>
                <a:ext uri="{FF2B5EF4-FFF2-40B4-BE49-F238E27FC236}">
                  <a16:creationId xmlns:a16="http://schemas.microsoft.com/office/drawing/2014/main" id="{902C7AD7-D9A2-29AE-3E0C-E5355CE473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58494" y="262722"/>
              <a:ext cx="1498600" cy="2413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opagated</a:t>
              </a:r>
              <a:r>
                <a:rPr kumimoji="0" lang="es-MX" altLang="es-CO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rganic</a:t>
              </a:r>
              <a:endParaRPr kumimoji="0" lang="es-MX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 Box 3">
              <a:extLst>
                <a:ext uri="{FF2B5EF4-FFF2-40B4-BE49-F238E27FC236}">
                  <a16:creationId xmlns:a16="http://schemas.microsoft.com/office/drawing/2014/main" id="{A4AA1F67-25D5-D752-82BB-EE56BC89EF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06962" y="265472"/>
              <a:ext cx="1498600" cy="2413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CO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onducive</a:t>
              </a:r>
              <a:endParaRPr kumimoji="0" lang="es-CO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4">
              <a:extLst>
                <a:ext uri="{FF2B5EF4-FFF2-40B4-BE49-F238E27FC236}">
                  <a16:creationId xmlns:a16="http://schemas.microsoft.com/office/drawing/2014/main" id="{39E1A52B-B588-1B0B-45BB-F91BAB3030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60008" y="266278"/>
              <a:ext cx="1498600" cy="2413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opagated</a:t>
              </a:r>
              <a:r>
                <a:rPr kumimoji="0" lang="es-MX" altLang="es-CO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onventional</a:t>
              </a:r>
              <a:endParaRPr kumimoji="0" lang="es-MX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 Box 5">
              <a:extLst>
                <a:ext uri="{FF2B5EF4-FFF2-40B4-BE49-F238E27FC236}">
                  <a16:creationId xmlns:a16="http://schemas.microsoft.com/office/drawing/2014/main" id="{57F1A74B-9FA3-F81E-9F51-A0DF0F1528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4552" y="265250"/>
              <a:ext cx="1498600" cy="40785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ropagated</a:t>
              </a:r>
              <a:r>
                <a:rPr kumimoji="0" lang="es-MX" altLang="es-CO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CO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organic</a:t>
              </a:r>
              <a:endParaRPr kumimoji="0" lang="es-MX" altLang="es-CO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 Box 16">
              <a:extLst>
                <a:ext uri="{FF2B5EF4-FFF2-40B4-BE49-F238E27FC236}">
                  <a16:creationId xmlns:a16="http://schemas.microsoft.com/office/drawing/2014/main" id="{BF352921-1DB6-4F1C-7A83-B11A699866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673" y="246888"/>
              <a:ext cx="404814" cy="52322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CO" altLang="es-CO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CO" altLang="es-CO" sz="14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  <a:r>
                <a:rPr kumimoji="0" lang="es-CO" altLang="es-CO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</a:t>
              </a:r>
              <a:endParaRPr kumimoji="0" lang="es-CO" altLang="es-CO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 Box 17">
              <a:extLst>
                <a:ext uri="{FF2B5EF4-FFF2-40B4-BE49-F238E27FC236}">
                  <a16:creationId xmlns:a16="http://schemas.microsoft.com/office/drawing/2014/main" id="{34725438-CF8F-EEDB-BAEB-C52DBE576E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 flipH="1" flipV="1">
              <a:off x="5794818" y="263685"/>
              <a:ext cx="404814" cy="52322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CO" altLang="es-CO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CO" altLang="es-CO" sz="14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  <a:r>
                <a:rPr kumimoji="0" lang="es-CO" altLang="es-CO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.</a:t>
              </a:r>
              <a:endParaRPr kumimoji="0" lang="es-CO" altLang="es-CO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021827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3</TotalTime>
  <Words>14</Words>
  <Application>Microsoft Office PowerPoint</Application>
  <PresentationFormat>Panorámica</PresentationFormat>
  <Paragraphs>1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iana Garcia</dc:creator>
  <cp:lastModifiedBy>Andrea Paola Zuluaga Cruz</cp:lastModifiedBy>
  <cp:revision>24</cp:revision>
  <dcterms:created xsi:type="dcterms:W3CDTF">2020-04-28T01:26:32Z</dcterms:created>
  <dcterms:modified xsi:type="dcterms:W3CDTF">2023-04-10T15:14:40Z</dcterms:modified>
</cp:coreProperties>
</file>